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721B13E-C8D9-4EC4-9396-C9F523D7BC6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l Figure 2. Baseline characteristics of wild-type and Interleukin-18 knock-out mice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Wild-type and Interleukin-18 knock-out mice did not present any statistically difference at baseline, before dietary intervention with high-sugar and high-saturated fat die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154FAD7-738B-4695-9273-A6470995255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0CC91-2E79-46EF-9827-3AE6879722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14C033-8949-4E26-9082-0AEECDEDA2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5AD07-41F2-43CE-8568-8574C8137E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AECCA3-4035-4727-891D-0AB25D6459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412922-46A7-4A48-84B4-139687FB51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72EE9-048B-4408-B87F-DAB24C43DF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C4B0E-E385-4CE7-BB8B-892F2EC8B8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B7AA3-06FB-4150-9BED-4C5380E260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53DF5-6879-4C14-B318-237DE1B424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8E257-1BEF-4BE0-B7C2-5090C8CFC7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4B641-602A-44CA-B9DD-48FB97D49E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3071F-CB1A-4CD4-A2B7-BF3B73B69B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7BA0966-09BC-4AF9-9172-4DC8EE9F22E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6"/>
          <p:cNvGrpSpPr/>
          <p:nvPr/>
        </p:nvGrpSpPr>
        <p:grpSpPr>
          <a:xfrm>
            <a:off x="254160" y="582480"/>
            <a:ext cx="6349680" cy="6808680"/>
            <a:chOff x="254160" y="582480"/>
            <a:chExt cx="6349680" cy="6808680"/>
          </a:xfrm>
        </p:grpSpPr>
        <p:pic>
          <p:nvPicPr>
            <p:cNvPr id="49" name="Picture 2" descr=""/>
            <p:cNvPicPr/>
            <p:nvPr/>
          </p:nvPicPr>
          <p:blipFill>
            <a:blip r:embed="rId1"/>
            <a:stretch/>
          </p:blipFill>
          <p:spPr>
            <a:xfrm>
              <a:off x="254160" y="582480"/>
              <a:ext cx="6349680" cy="650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109"/>
            <p:cNvSpPr/>
            <p:nvPr/>
          </p:nvSpPr>
          <p:spPr>
            <a:xfrm>
              <a:off x="2609640" y="6962400"/>
              <a:ext cx="146448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</a:rPr>
                <a:t>Wild type (N=6-8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</a:rPr>
                <a:t>IL-18 KO (N=7-9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351"/>
            <p:cNvSpPr/>
            <p:nvPr/>
          </p:nvSpPr>
          <p:spPr>
            <a:xfrm>
              <a:off x="2509560" y="7177680"/>
              <a:ext cx="183240" cy="1162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351"/>
            <p:cNvSpPr/>
            <p:nvPr/>
          </p:nvSpPr>
          <p:spPr>
            <a:xfrm>
              <a:off x="2504160" y="7018560"/>
              <a:ext cx="186840" cy="1188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" name="Rectangle 7"/>
          <p:cNvSpPr/>
          <p:nvPr/>
        </p:nvSpPr>
        <p:spPr>
          <a:xfrm>
            <a:off x="274680" y="7842240"/>
            <a:ext cx="635004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l Figure 2. Baseline characteristics of wild-type and Interleukin-18 knock-out mice.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Wild-type and Interleukin-18 knock-out mice did not present any statistically difference at baseline, before dietary intervention with high-sugar and high-saturated fat diet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16T01:08:33Z</dcterms:created>
  <dc:creator>somtech</dc:creator>
  <dc:description/>
  <dc:language>en-US</dc:language>
  <cp:lastModifiedBy>ravikumar.n</cp:lastModifiedBy>
  <cp:lastPrinted>2016-07-15T14:08:26Z</cp:lastPrinted>
  <dcterms:modified xsi:type="dcterms:W3CDTF">2017-03-10T09:44:22Z</dcterms:modified>
  <cp:revision>228</cp:revision>
  <dc:subject/>
  <dc:title>PowerPoint Presentation</dc:title>
</cp:coreProperties>
</file>